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23" d="100"/>
          <a:sy n="123" d="100"/>
        </p:scale>
        <p:origin x="80" y="4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4BBA4EA-DF46-46BE-8F66-9A852CBC095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3C10D8B3-CF47-4876-979B-E0386EDF6B5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76EE713-33E6-4690-8396-48C871B1DC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793B3-ABE2-4AEC-80DD-5E81025B5AD8}" type="datetimeFigureOut">
              <a:rPr lang="zh-CN" altLang="en-US" smtClean="0"/>
              <a:t>2021/2/1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D6EA4D4-9A76-4B21-84E7-8665943298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09AE94A-6423-4969-81F4-87C32EC3A6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698190-44F9-456F-8FC1-5313340945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486376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B60C93D-71D9-459F-83DB-8992A266C67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00D09A20-4F90-4E2F-BE47-122E8C10717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B52C619-9D91-4C48-BA91-9D099DAC59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793B3-ABE2-4AEC-80DD-5E81025B5AD8}" type="datetimeFigureOut">
              <a:rPr lang="zh-CN" altLang="en-US" smtClean="0"/>
              <a:t>2021/2/1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F3BCDA0-B271-42AB-8DFE-12D389E94D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D86D22D-3DBF-4EA8-ABA7-6001A7BFBE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698190-44F9-456F-8FC1-5313340945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385197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F4F3BAB1-AF9C-4B25-B7E6-2877EC678F6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A3A4A7E5-FAA1-460E-B4EE-4966FCCFE13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8B00876-D9C1-4A99-89C3-065A480E76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793B3-ABE2-4AEC-80DD-5E81025B5AD8}" type="datetimeFigureOut">
              <a:rPr lang="zh-CN" altLang="en-US" smtClean="0"/>
              <a:t>2021/2/1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E0218C1-2E79-4A1D-BE2C-D216127169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06099E9-B5B4-48A5-9447-8F9AEB9037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698190-44F9-456F-8FC1-5313340945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050607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C633DC8-2AC2-421B-B00D-D7A73CFAE14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82C70B0-7011-416F-92FC-61EF54E4114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9D779F0-DDFF-4C49-8844-676B5C8399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793B3-ABE2-4AEC-80DD-5E81025B5AD8}" type="datetimeFigureOut">
              <a:rPr lang="zh-CN" altLang="en-US" smtClean="0"/>
              <a:t>2021/2/1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1EAFC73-EEED-4D43-AF5A-DA06E653B4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A3E87F6-DEE7-4564-B137-3D10D38D4D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698190-44F9-456F-8FC1-5313340945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067031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4D84106-5261-4BC1-B475-64081ABE9B0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13A39AA-D2A7-4A64-A5C3-2F78CDC9055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7A3C0B7-F1BC-4BDB-9170-8639ACCF9C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793B3-ABE2-4AEC-80DD-5E81025B5AD8}" type="datetimeFigureOut">
              <a:rPr lang="zh-CN" altLang="en-US" smtClean="0"/>
              <a:t>2021/2/1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B266392-7E63-466E-B3CB-FEC0123686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7D5B11B-2922-4561-8547-492FA20F12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698190-44F9-456F-8FC1-5313340945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683948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98F4A71-DB7B-4F72-BA92-08F8133C7AC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2ACD367-3165-4B1B-86AC-0FF039D9CC4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DB87F34E-3D10-43B4-9659-7304D483208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0E74918-A97C-491D-A0E9-E51935D341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793B3-ABE2-4AEC-80DD-5E81025B5AD8}" type="datetimeFigureOut">
              <a:rPr lang="zh-CN" altLang="en-US" smtClean="0"/>
              <a:t>2021/2/1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BB53A1F-04C7-4DCB-A8A8-BDC590C03D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80B7FE3-E444-4E09-A372-F93D9CB7A1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698190-44F9-456F-8FC1-5313340945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614859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B01B861-9BEE-4B98-99B6-AFA7E648057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D23F13F8-3681-45D1-9D58-829815C6FA1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22062B98-7CFE-40F5-8A8D-999FB70F85C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5F334DA5-1320-4440-951D-53891698D97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E523F73A-4236-497E-AA63-B13828033DB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7871433D-D6BF-469C-B371-18DE754DE1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793B3-ABE2-4AEC-80DD-5E81025B5AD8}" type="datetimeFigureOut">
              <a:rPr lang="zh-CN" altLang="en-US" smtClean="0"/>
              <a:t>2021/2/11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2D0EB1B3-D877-41FD-8CF2-1D50C8B1CC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4FDF5906-2DCC-490A-9698-175B72E143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698190-44F9-456F-8FC1-5313340945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771114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3C60302-69EC-4A19-9283-7B15D88AF36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70BDC5B1-6F8F-419F-A5B6-E563846DDC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793B3-ABE2-4AEC-80DD-5E81025B5AD8}" type="datetimeFigureOut">
              <a:rPr lang="zh-CN" altLang="en-US" smtClean="0"/>
              <a:t>2021/2/11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2C179CE6-AA4D-4E95-89B8-EB3DB8AB28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FA87CA6A-1152-4256-A37A-1A1BE8027D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698190-44F9-456F-8FC1-5313340945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114205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61E37FC4-4774-4CE9-9963-21D1C7CF1F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793B3-ABE2-4AEC-80DD-5E81025B5AD8}" type="datetimeFigureOut">
              <a:rPr lang="zh-CN" altLang="en-US" smtClean="0"/>
              <a:t>2021/2/11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CFC559C3-2EC5-4AE2-AF3C-8152794791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69EE0A29-5CA4-43C3-A8CA-EABE7B54CA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698190-44F9-456F-8FC1-5313340945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863320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7644ACB-8C19-4DAA-A82F-F8C5357CCE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B8D99D9-69C6-4477-9827-6894C8E4CE9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CC360287-ED8F-40E5-8BCE-E3941A3B906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C81321EF-81DC-4DB1-A540-5010750B43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793B3-ABE2-4AEC-80DD-5E81025B5AD8}" type="datetimeFigureOut">
              <a:rPr lang="zh-CN" altLang="en-US" smtClean="0"/>
              <a:t>2021/2/1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7D87B957-C080-4010-ACF4-3CD3C050A3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4B70A13-4318-4561-9FAB-BADFF58CFF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698190-44F9-456F-8FC1-5313340945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586860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85A30AB-37D8-4632-A836-32B745918F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4C2FDE86-DAB0-4F39-B03F-B397B8DB667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187733BD-49E1-42EC-9165-B7B98C9D68F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D98C340-6646-4715-96CA-1FDD0E078E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793B3-ABE2-4AEC-80DD-5E81025B5AD8}" type="datetimeFigureOut">
              <a:rPr lang="zh-CN" altLang="en-US" smtClean="0"/>
              <a:t>2021/2/1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AA59620-1ED8-4EEA-A221-02D2AF7A09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6C7C9151-367E-4D0B-8D1D-BF0772B3B2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698190-44F9-456F-8FC1-5313340945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673447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AAE5414E-803D-4070-8E7D-36E1F414C0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EA2C64F-F18B-4F05-A847-57256105FA8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B0291B0-75F6-4FD0-9B37-035EFF79531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4793B3-ABE2-4AEC-80DD-5E81025B5AD8}" type="datetimeFigureOut">
              <a:rPr lang="zh-CN" altLang="en-US" smtClean="0"/>
              <a:t>2021/2/1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7D20A5D-45B2-419A-B72B-66C7096A718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37F4619-C1FF-4927-90F4-D1773C9292B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698190-44F9-456F-8FC1-5313340945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716097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图片 6" descr="图表, 折线图&#10;&#10;描述已自动生成">
            <a:extLst>
              <a:ext uri="{FF2B5EF4-FFF2-40B4-BE49-F238E27FC236}">
                <a16:creationId xmlns:a16="http://schemas.microsoft.com/office/drawing/2014/main" id="{16634B8D-E941-4EEB-9A3E-B2C3E77AB34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3467" y="1391709"/>
            <a:ext cx="5291666" cy="4074582"/>
          </a:xfrm>
          <a:prstGeom prst="rect">
            <a:avLst/>
          </a:prstGeom>
        </p:spPr>
      </p:pic>
      <p:pic>
        <p:nvPicPr>
          <p:cNvPr id="9" name="图片 8" descr="图表&#10;&#10;描述已自动生成">
            <a:extLst>
              <a:ext uri="{FF2B5EF4-FFF2-40B4-BE49-F238E27FC236}">
                <a16:creationId xmlns:a16="http://schemas.microsoft.com/office/drawing/2014/main" id="{E9698437-4BB3-4779-A628-5AB5C5CD4C2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56865" y="1391708"/>
            <a:ext cx="5291667" cy="4074583"/>
          </a:xfrm>
          <a:prstGeom prst="rect">
            <a:avLst/>
          </a:prstGeom>
        </p:spPr>
      </p:pic>
      <p:sp>
        <p:nvSpPr>
          <p:cNvPr id="11" name="文本框 10">
            <a:extLst>
              <a:ext uri="{FF2B5EF4-FFF2-40B4-BE49-F238E27FC236}">
                <a16:creationId xmlns:a16="http://schemas.microsoft.com/office/drawing/2014/main" id="{8F89F49F-3FBC-4077-B74A-CB54319795E8}"/>
              </a:ext>
            </a:extLst>
          </p:cNvPr>
          <p:cNvSpPr txBox="1"/>
          <p:nvPr/>
        </p:nvSpPr>
        <p:spPr>
          <a:xfrm>
            <a:off x="718088" y="5661394"/>
            <a:ext cx="10830444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8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icrosoft YaHei UI" panose="020B0503020204020204" pitchFamily="34" charset="-122"/>
                <a:cs typeface="Times New Roman" panose="02020603050405020304" pitchFamily="18" charset="0"/>
              </a:rPr>
              <a:t>A sensitivity analysis excluding the initial 127 overlapping patients,</a:t>
            </a:r>
            <a:r>
              <a:rPr lang="en-US" altLang="zh-CN" sz="1800" b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t</a:t>
            </a:r>
            <a:r>
              <a:rPr lang="en-US" altLang="zh-CN" sz="18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hree notably different curves were also obtained for long-term post-SBRT survival</a:t>
            </a:r>
            <a:r>
              <a:rPr lang="en-US" altLang="zh-CN" sz="18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icrosoft YaHei UI" panose="020B0503020204020204" pitchFamily="34" charset="-122"/>
                <a:cs typeface="Times New Roman" panose="02020603050405020304" pitchFamily="18" charset="0"/>
              </a:rPr>
              <a:t> for log-rank testing between the high, moderate and low dose groups</a:t>
            </a:r>
            <a:endParaRPr lang="zh-CN" altLang="zh-CN" sz="16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5B25AA82-C828-46DC-BE74-FF0A2291414B}"/>
              </a:ext>
            </a:extLst>
          </p:cNvPr>
          <p:cNvSpPr txBox="1"/>
          <p:nvPr/>
        </p:nvSpPr>
        <p:spPr>
          <a:xfrm>
            <a:off x="3048000" y="3245625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b="0" i="0" dirty="0">
                <a:solidFill>
                  <a:srgbClr val="919599"/>
                </a:solidFill>
                <a:effectLst/>
                <a:latin typeface="Microsoft YaHei" panose="020B0503020204020204" pitchFamily="34" charset="-122"/>
                <a:ea typeface="Microsoft YaHei" panose="020B0503020204020204" pitchFamily="34" charset="-122"/>
              </a:rPr>
              <a:t>supplementary materials</a:t>
            </a:r>
            <a:endParaRPr lang="zh-CN" altLang="en-US" dirty="0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632CAFC2-B551-4A41-A67C-0E30130D613D}"/>
              </a:ext>
            </a:extLst>
          </p:cNvPr>
          <p:cNvSpPr txBox="1"/>
          <p:nvPr/>
        </p:nvSpPr>
        <p:spPr>
          <a:xfrm>
            <a:off x="1126210" y="446953"/>
            <a:ext cx="270187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kern="100" dirty="0">
                <a:solidFill>
                  <a:srgbClr val="000000"/>
                </a:solidFill>
                <a:latin typeface="Times New Roman" panose="02020603050405020304" pitchFamily="18" charset="0"/>
                <a:ea typeface="Microsoft YaHei UI" panose="020B0503020204020204" pitchFamily="34" charset="-122"/>
                <a:cs typeface="Times New Roman" panose="02020603050405020304" pitchFamily="18" charset="0"/>
              </a:rPr>
              <a:t>supplementary materials</a:t>
            </a:r>
            <a:endParaRPr lang="zh-CN" altLang="en-US" kern="100" dirty="0">
              <a:solidFill>
                <a:srgbClr val="000000"/>
              </a:solidFill>
              <a:latin typeface="Times New Roman" panose="02020603050405020304" pitchFamily="18" charset="0"/>
              <a:ea typeface="Microsoft YaHei UI" panose="020B0503020204020204" pitchFamily="34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4948785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 descr="图表&#10;&#10;描述已自动生成">
            <a:extLst>
              <a:ext uri="{FF2B5EF4-FFF2-40B4-BE49-F238E27FC236}">
                <a16:creationId xmlns:a16="http://schemas.microsoft.com/office/drawing/2014/main" id="{33EE4B7C-CAFD-4DAC-96B2-10B0EA7DAC9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00940" y="334102"/>
            <a:ext cx="6494355" cy="5155146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0AD1D9A8-4385-455A-8DA7-8C3967FF4989}"/>
              </a:ext>
            </a:extLst>
          </p:cNvPr>
          <p:cNvSpPr txBox="1"/>
          <p:nvPr/>
        </p:nvSpPr>
        <p:spPr>
          <a:xfrm>
            <a:off x="1126210" y="446953"/>
            <a:ext cx="270187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kern="100" dirty="0">
                <a:solidFill>
                  <a:srgbClr val="000000"/>
                </a:solidFill>
                <a:latin typeface="Times New Roman" panose="02020603050405020304" pitchFamily="18" charset="0"/>
                <a:ea typeface="Microsoft YaHei UI" panose="020B0503020204020204" pitchFamily="34" charset="-122"/>
                <a:cs typeface="Times New Roman" panose="02020603050405020304" pitchFamily="18" charset="0"/>
              </a:rPr>
              <a:t>supplementary materials</a:t>
            </a:r>
            <a:endParaRPr lang="zh-CN" altLang="en-US" kern="100" dirty="0">
              <a:solidFill>
                <a:srgbClr val="000000"/>
              </a:solidFill>
              <a:latin typeface="Times New Roman" panose="02020603050405020304" pitchFamily="18" charset="0"/>
              <a:ea typeface="Microsoft YaHei UI" panose="020B0503020204020204" pitchFamily="34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764099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39</Words>
  <Application>Microsoft Office PowerPoint</Application>
  <PresentationFormat>宽屏</PresentationFormat>
  <Paragraphs>4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8" baseType="lpstr">
      <vt:lpstr>等线</vt:lpstr>
      <vt:lpstr>等线 Light</vt:lpstr>
      <vt:lpstr>Microsoft YaHei</vt:lpstr>
      <vt:lpstr>Arial</vt:lpstr>
      <vt:lpstr>Times New Roman</vt:lpstr>
      <vt:lpstr>Office 主题​​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su tingshi</dc:creator>
  <cp:lastModifiedBy>su tingshi</cp:lastModifiedBy>
  <cp:revision>1</cp:revision>
  <dcterms:created xsi:type="dcterms:W3CDTF">2021-02-10T17:45:35Z</dcterms:created>
  <dcterms:modified xsi:type="dcterms:W3CDTF">2021-02-10T17:48:44Z</dcterms:modified>
</cp:coreProperties>
</file>